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3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31" r:id="rId2"/>
    <p:sldId id="330" r:id="rId3"/>
    <p:sldId id="333" r:id="rId4"/>
    <p:sldId id="311" r:id="rId5"/>
    <p:sldId id="336" r:id="rId6"/>
    <p:sldId id="31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002" autoAdjust="0"/>
    <p:restoredTop sz="94660"/>
  </p:normalViewPr>
  <p:slideViewPr>
    <p:cSldViewPr snapToGrid="0">
      <p:cViewPr varScale="1">
        <p:scale>
          <a:sx n="59" d="100"/>
          <a:sy n="59" d="100"/>
        </p:scale>
        <p:origin x="100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50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phil%20Research\Biofortification\hp\YSL%20haplotyp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phil%20Research\Biofortification\YSL\embryo%20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phil_Research\Biofortification\hp\YSL%20haplotyp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phil_Research\Biofortification\hp\YSL%20haplotyp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phil_Research\Biofortification\hp\taysl7-7a.fnl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phil_Research\Biofortification\hp\YSL%20haplotype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Sheet4!$B$1</c:f>
              <c:strCache>
                <c:ptCount val="1"/>
                <c:pt idx="0">
                  <c:v>C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4!$A$2:$A$5</c:f>
              <c:strCache>
                <c:ptCount val="4"/>
                <c:pt idx="0">
                  <c:v>Cultivars</c:v>
                </c:pt>
                <c:pt idx="1">
                  <c:v>Landraces</c:v>
                </c:pt>
                <c:pt idx="2">
                  <c:v>Spring</c:v>
                </c:pt>
                <c:pt idx="3">
                  <c:v>Winter</c:v>
                </c:pt>
              </c:strCache>
            </c:strRef>
          </c:cat>
          <c:val>
            <c:numRef>
              <c:f>Sheet4!$B$2:$B$5</c:f>
              <c:numCache>
                <c:formatCode>General</c:formatCode>
                <c:ptCount val="4"/>
                <c:pt idx="0">
                  <c:v>845</c:v>
                </c:pt>
                <c:pt idx="1">
                  <c:v>746</c:v>
                </c:pt>
                <c:pt idx="2">
                  <c:v>181</c:v>
                </c:pt>
                <c:pt idx="3">
                  <c:v>13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79-42FB-9CE0-DF243630D463}"/>
            </c:ext>
          </c:extLst>
        </c:ser>
        <c:ser>
          <c:idx val="1"/>
          <c:order val="1"/>
          <c:tx>
            <c:strRef>
              <c:f>Sheet4!$C$1</c:f>
              <c:strCache>
                <c:ptCount val="1"/>
                <c:pt idx="0">
                  <c:v>T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4!$A$2:$A$5</c:f>
              <c:strCache>
                <c:ptCount val="4"/>
                <c:pt idx="0">
                  <c:v>Cultivars</c:v>
                </c:pt>
                <c:pt idx="1">
                  <c:v>Landraces</c:v>
                </c:pt>
                <c:pt idx="2">
                  <c:v>Spring</c:v>
                </c:pt>
                <c:pt idx="3">
                  <c:v>Winter</c:v>
                </c:pt>
              </c:strCache>
            </c:strRef>
          </c:cat>
          <c:val>
            <c:numRef>
              <c:f>Sheet4!$C$2:$C$5</c:f>
              <c:numCache>
                <c:formatCode>General</c:formatCode>
                <c:ptCount val="4"/>
                <c:pt idx="0">
                  <c:v>46</c:v>
                </c:pt>
                <c:pt idx="1">
                  <c:v>8</c:v>
                </c:pt>
                <c:pt idx="2">
                  <c:v>1</c:v>
                </c:pt>
                <c:pt idx="3">
                  <c:v>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C79-42FB-9CE0-DF243630D4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60713791"/>
        <c:axId val="360708991"/>
      </c:barChart>
      <c:catAx>
        <c:axId val="36071379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60708991"/>
        <c:crosses val="autoZero"/>
        <c:auto val="1"/>
        <c:lblAlgn val="ctr"/>
        <c:lblOffset val="100"/>
        <c:noMultiLvlLbl val="0"/>
      </c:catAx>
      <c:valAx>
        <c:axId val="360708991"/>
        <c:scaling>
          <c:orientation val="minMax"/>
          <c:min val="0"/>
        </c:scaling>
        <c:delete val="0"/>
        <c:axPos val="b"/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6071379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1"/>
          <c:order val="0"/>
          <c:tx>
            <c:strRef>
              <c:f>Sheet1!$C$27</c:f>
              <c:strCache>
                <c:ptCount val="1"/>
                <c:pt idx="0">
                  <c:v>A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Sheet1!$D$25:$AK$25</c:f>
              <c:strCache>
                <c:ptCount val="26"/>
                <c:pt idx="0">
                  <c:v>Embryo</c:v>
                </c:pt>
                <c:pt idx="25">
                  <c:v>Endosperm</c:v>
                </c:pt>
              </c:strCache>
            </c:strRef>
          </c:cat>
          <c:val>
            <c:numRef>
              <c:f>Sheet1!$D$27:$AK$27</c:f>
              <c:numCache>
                <c:formatCode>General</c:formatCode>
                <c:ptCount val="34"/>
                <c:pt idx="0">
                  <c:v>1.32333E-2</c:v>
                </c:pt>
                <c:pt idx="1">
                  <c:v>0</c:v>
                </c:pt>
                <c:pt idx="2">
                  <c:v>0</c:v>
                </c:pt>
                <c:pt idx="3">
                  <c:v>8.6666699999999996E-3</c:v>
                </c:pt>
                <c:pt idx="4">
                  <c:v>0</c:v>
                </c:pt>
                <c:pt idx="5">
                  <c:v>0</c:v>
                </c:pt>
                <c:pt idx="6">
                  <c:v>3.6333300000000002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3.5666700000000001E-3</c:v>
                </c:pt>
                <c:pt idx="11">
                  <c:v>3.1333300000000001E-3</c:v>
                </c:pt>
                <c:pt idx="12">
                  <c:v>3.8333299999999998E-3</c:v>
                </c:pt>
                <c:pt idx="13">
                  <c:v>0</c:v>
                </c:pt>
                <c:pt idx="14">
                  <c:v>3.9733299999999999E-2</c:v>
                </c:pt>
                <c:pt idx="15">
                  <c:v>6.7666699999999998E-3</c:v>
                </c:pt>
                <c:pt idx="16">
                  <c:v>2.5933299999999999E-2</c:v>
                </c:pt>
                <c:pt idx="17">
                  <c:v>1.0733299999999999E-2</c:v>
                </c:pt>
                <c:pt idx="18">
                  <c:v>3.6666699999999999E-3</c:v>
                </c:pt>
                <c:pt idx="19">
                  <c:v>0</c:v>
                </c:pt>
                <c:pt idx="20">
                  <c:v>3.73333E-3</c:v>
                </c:pt>
                <c:pt idx="21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ACA-4CAA-965A-52454FC4127E}"/>
            </c:ext>
          </c:extLst>
        </c:ser>
        <c:ser>
          <c:idx val="2"/>
          <c:order val="1"/>
          <c:tx>
            <c:strRef>
              <c:f>Sheet1!$C$28</c:f>
              <c:strCache>
                <c:ptCount val="1"/>
                <c:pt idx="0">
                  <c:v>B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Sheet1!$D$25:$AK$25</c:f>
              <c:strCache>
                <c:ptCount val="26"/>
                <c:pt idx="0">
                  <c:v>Embryo</c:v>
                </c:pt>
                <c:pt idx="25">
                  <c:v>Endosperm</c:v>
                </c:pt>
              </c:strCache>
            </c:strRef>
          </c:cat>
          <c:val>
            <c:numRef>
              <c:f>Sheet1!$D$28:$AK$28</c:f>
              <c:numCache>
                <c:formatCode>General</c:formatCode>
                <c:ptCount val="34"/>
                <c:pt idx="0">
                  <c:v>3.7000000000000002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8.2666700000000003E-3</c:v>
                </c:pt>
                <c:pt idx="17">
                  <c:v>0</c:v>
                </c:pt>
                <c:pt idx="18">
                  <c:v>3.36667E-3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ACA-4CAA-965A-52454FC4127E}"/>
            </c:ext>
          </c:extLst>
        </c:ser>
        <c:ser>
          <c:idx val="3"/>
          <c:order val="2"/>
          <c:tx>
            <c:strRef>
              <c:f>Sheet1!$C$29</c:f>
              <c:strCache>
                <c:ptCount val="1"/>
                <c:pt idx="0">
                  <c:v>D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Sheet1!$D$25:$AK$25</c:f>
              <c:strCache>
                <c:ptCount val="26"/>
                <c:pt idx="0">
                  <c:v>Embryo</c:v>
                </c:pt>
                <c:pt idx="25">
                  <c:v>Endosperm</c:v>
                </c:pt>
              </c:strCache>
            </c:strRef>
          </c:cat>
          <c:val>
            <c:numRef>
              <c:f>Sheet1!$D$29:$AK$29</c:f>
              <c:numCache>
                <c:formatCode>General</c:formatCode>
                <c:ptCount val="34"/>
                <c:pt idx="0">
                  <c:v>0</c:v>
                </c:pt>
                <c:pt idx="1">
                  <c:v>3.73333E-3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3.4666699999999998E-3</c:v>
                </c:pt>
                <c:pt idx="7">
                  <c:v>3.0666700000000001E-3</c:v>
                </c:pt>
                <c:pt idx="8">
                  <c:v>0</c:v>
                </c:pt>
                <c:pt idx="9">
                  <c:v>3.1666699999999999E-3</c:v>
                </c:pt>
                <c:pt idx="10">
                  <c:v>0</c:v>
                </c:pt>
                <c:pt idx="11">
                  <c:v>5.9666700000000003E-3</c:v>
                </c:pt>
                <c:pt idx="12">
                  <c:v>3.6333300000000002E-3</c:v>
                </c:pt>
                <c:pt idx="13">
                  <c:v>0</c:v>
                </c:pt>
                <c:pt idx="14">
                  <c:v>0</c:v>
                </c:pt>
                <c:pt idx="15">
                  <c:v>1.2800000000000001E-2</c:v>
                </c:pt>
                <c:pt idx="16">
                  <c:v>9.7666699999999999E-3</c:v>
                </c:pt>
                <c:pt idx="17">
                  <c:v>1.0733299999999999E-2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3.5333299999999999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ACA-4CAA-965A-52454FC412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44927743"/>
        <c:axId val="644899903"/>
      </c:lineChart>
      <c:catAx>
        <c:axId val="6449277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44899903"/>
        <c:crosses val="autoZero"/>
        <c:auto val="1"/>
        <c:lblAlgn val="ctr"/>
        <c:lblOffset val="100"/>
        <c:noMultiLvlLbl val="0"/>
      </c:catAx>
      <c:valAx>
        <c:axId val="64489990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4492774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1"/>
          <c:order val="0"/>
          <c:tx>
            <c:strRef>
              <c:f>'embryo data'!$C$3</c:f>
              <c:strCache>
                <c:ptCount val="1"/>
                <c:pt idx="0">
                  <c:v>A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embryo data'!$D$1:$AK$1</c:f>
              <c:strCache>
                <c:ptCount val="26"/>
                <c:pt idx="0">
                  <c:v>Embryo</c:v>
                </c:pt>
                <c:pt idx="25">
                  <c:v>Endosperm</c:v>
                </c:pt>
              </c:strCache>
            </c:strRef>
          </c:cat>
          <c:val>
            <c:numRef>
              <c:f>'embryo data'!$D$3:$AK$3</c:f>
              <c:numCache>
                <c:formatCode>General</c:formatCode>
                <c:ptCount val="34"/>
                <c:pt idx="0">
                  <c:v>0.409667</c:v>
                </c:pt>
                <c:pt idx="1">
                  <c:v>0.27183299999999999</c:v>
                </c:pt>
                <c:pt idx="2">
                  <c:v>0.30556699999999998</c:v>
                </c:pt>
                <c:pt idx="3">
                  <c:v>0.2029</c:v>
                </c:pt>
                <c:pt idx="4">
                  <c:v>0.13070000000000001</c:v>
                </c:pt>
                <c:pt idx="5">
                  <c:v>0.170933</c:v>
                </c:pt>
                <c:pt idx="6">
                  <c:v>0.22889999999999999</c:v>
                </c:pt>
                <c:pt idx="7">
                  <c:v>0.35436699999999999</c:v>
                </c:pt>
                <c:pt idx="8">
                  <c:v>0.43740000000000001</c:v>
                </c:pt>
                <c:pt idx="9">
                  <c:v>0.27596700000000002</c:v>
                </c:pt>
                <c:pt idx="10">
                  <c:v>0.70826699999999998</c:v>
                </c:pt>
                <c:pt idx="11">
                  <c:v>0.74063299999999999</c:v>
                </c:pt>
                <c:pt idx="12">
                  <c:v>0.55616699999999997</c:v>
                </c:pt>
                <c:pt idx="13">
                  <c:v>0.58574999999999999</c:v>
                </c:pt>
                <c:pt idx="14">
                  <c:v>0.55746700000000005</c:v>
                </c:pt>
                <c:pt idx="15">
                  <c:v>0.88759999999999994</c:v>
                </c:pt>
                <c:pt idx="16">
                  <c:v>0.81793300000000002</c:v>
                </c:pt>
                <c:pt idx="17">
                  <c:v>0.760467</c:v>
                </c:pt>
                <c:pt idx="18">
                  <c:v>1.0033300000000001</c:v>
                </c:pt>
                <c:pt idx="19">
                  <c:v>1.2728699999999999</c:v>
                </c:pt>
                <c:pt idx="20">
                  <c:v>0.9456</c:v>
                </c:pt>
                <c:pt idx="21">
                  <c:v>1.0686</c:v>
                </c:pt>
                <c:pt idx="25">
                  <c:v>1.2049000000000001</c:v>
                </c:pt>
                <c:pt idx="26">
                  <c:v>1.87425</c:v>
                </c:pt>
                <c:pt idx="27">
                  <c:v>0.35980000000000001</c:v>
                </c:pt>
                <c:pt idx="28">
                  <c:v>0.2079</c:v>
                </c:pt>
                <c:pt idx="29">
                  <c:v>0.1842</c:v>
                </c:pt>
                <c:pt idx="30">
                  <c:v>0</c:v>
                </c:pt>
                <c:pt idx="31">
                  <c:v>0.23619999999999999</c:v>
                </c:pt>
                <c:pt idx="32">
                  <c:v>0</c:v>
                </c:pt>
                <c:pt idx="33">
                  <c:v>7.5399999999999995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9F0-492B-8922-0FF397DB8ABD}"/>
            </c:ext>
          </c:extLst>
        </c:ser>
        <c:ser>
          <c:idx val="2"/>
          <c:order val="1"/>
          <c:tx>
            <c:strRef>
              <c:f>'embryo data'!$C$4</c:f>
              <c:strCache>
                <c:ptCount val="1"/>
                <c:pt idx="0">
                  <c:v>B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embryo data'!$D$1:$AK$1</c:f>
              <c:strCache>
                <c:ptCount val="26"/>
                <c:pt idx="0">
                  <c:v>Embryo</c:v>
                </c:pt>
                <c:pt idx="25">
                  <c:v>Endosperm</c:v>
                </c:pt>
              </c:strCache>
            </c:strRef>
          </c:cat>
          <c:val>
            <c:numRef>
              <c:f>'embryo data'!$D$4:$AK$4</c:f>
              <c:numCache>
                <c:formatCode>General</c:formatCode>
                <c:ptCount val="34"/>
                <c:pt idx="0">
                  <c:v>0.20113300000000001</c:v>
                </c:pt>
                <c:pt idx="1">
                  <c:v>0.45660000000000001</c:v>
                </c:pt>
                <c:pt idx="2">
                  <c:v>1.83073</c:v>
                </c:pt>
                <c:pt idx="3">
                  <c:v>1.12323</c:v>
                </c:pt>
                <c:pt idx="4">
                  <c:v>0.67169999999999996</c:v>
                </c:pt>
                <c:pt idx="5">
                  <c:v>1.83453</c:v>
                </c:pt>
                <c:pt idx="6">
                  <c:v>1.3441700000000001</c:v>
                </c:pt>
                <c:pt idx="7">
                  <c:v>2.3163999999999998</c:v>
                </c:pt>
                <c:pt idx="8">
                  <c:v>2.5211700000000001</c:v>
                </c:pt>
                <c:pt idx="9">
                  <c:v>5.5008999999999997</c:v>
                </c:pt>
                <c:pt idx="10">
                  <c:v>1.9446699999999999</c:v>
                </c:pt>
                <c:pt idx="11">
                  <c:v>0.291433</c:v>
                </c:pt>
                <c:pt idx="12">
                  <c:v>0.51113299999999995</c:v>
                </c:pt>
                <c:pt idx="13">
                  <c:v>0.58350000000000002</c:v>
                </c:pt>
                <c:pt idx="14">
                  <c:v>0.30143300000000001</c:v>
                </c:pt>
                <c:pt idx="15">
                  <c:v>0.75353300000000001</c:v>
                </c:pt>
                <c:pt idx="16">
                  <c:v>0.290267</c:v>
                </c:pt>
                <c:pt idx="17">
                  <c:v>0.44856699999999999</c:v>
                </c:pt>
                <c:pt idx="18">
                  <c:v>0.53273300000000001</c:v>
                </c:pt>
                <c:pt idx="19">
                  <c:v>0.42366700000000002</c:v>
                </c:pt>
                <c:pt idx="20">
                  <c:v>0.62656699999999999</c:v>
                </c:pt>
                <c:pt idx="21">
                  <c:v>0.461067</c:v>
                </c:pt>
                <c:pt idx="25">
                  <c:v>2.1633</c:v>
                </c:pt>
                <c:pt idx="26">
                  <c:v>8.7001000000000008</c:v>
                </c:pt>
                <c:pt idx="27">
                  <c:v>2.6230799999999999</c:v>
                </c:pt>
                <c:pt idx="28">
                  <c:v>4.6467700000000001</c:v>
                </c:pt>
                <c:pt idx="29">
                  <c:v>7.6663300000000003</c:v>
                </c:pt>
                <c:pt idx="30">
                  <c:v>7.41235</c:v>
                </c:pt>
                <c:pt idx="31">
                  <c:v>4.0074699999999996</c:v>
                </c:pt>
                <c:pt idx="32">
                  <c:v>7.3019499999999997</c:v>
                </c:pt>
                <c:pt idx="33">
                  <c:v>7.19712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9F0-492B-8922-0FF397DB8ABD}"/>
            </c:ext>
          </c:extLst>
        </c:ser>
        <c:ser>
          <c:idx val="3"/>
          <c:order val="2"/>
          <c:tx>
            <c:strRef>
              <c:f>'embryo data'!$C$5</c:f>
              <c:strCache>
                <c:ptCount val="1"/>
                <c:pt idx="0">
                  <c:v>D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embryo data'!$D$1:$AK$1</c:f>
              <c:strCache>
                <c:ptCount val="26"/>
                <c:pt idx="0">
                  <c:v>Embryo</c:v>
                </c:pt>
                <c:pt idx="25">
                  <c:v>Endosperm</c:v>
                </c:pt>
              </c:strCache>
            </c:strRef>
          </c:cat>
          <c:val>
            <c:numRef>
              <c:f>'embryo data'!$D$5:$AK$5</c:f>
              <c:numCache>
                <c:formatCode>General</c:formatCode>
                <c:ptCount val="34"/>
                <c:pt idx="0">
                  <c:v>0.25203300000000001</c:v>
                </c:pt>
                <c:pt idx="1">
                  <c:v>0.25206699999999999</c:v>
                </c:pt>
                <c:pt idx="2">
                  <c:v>0.4</c:v>
                </c:pt>
                <c:pt idx="3">
                  <c:v>0.60656699999999997</c:v>
                </c:pt>
                <c:pt idx="4">
                  <c:v>0.409833</c:v>
                </c:pt>
                <c:pt idx="5">
                  <c:v>0.405667</c:v>
                </c:pt>
                <c:pt idx="6">
                  <c:v>0.90236700000000003</c:v>
                </c:pt>
                <c:pt idx="7">
                  <c:v>0.79626699999999995</c:v>
                </c:pt>
                <c:pt idx="8">
                  <c:v>0.79706699999999997</c:v>
                </c:pt>
                <c:pt idx="9">
                  <c:v>0.82963299999999995</c:v>
                </c:pt>
                <c:pt idx="10">
                  <c:v>0.38456699999999999</c:v>
                </c:pt>
                <c:pt idx="11">
                  <c:v>0.35586699999999999</c:v>
                </c:pt>
                <c:pt idx="12">
                  <c:v>0.41813299999999998</c:v>
                </c:pt>
                <c:pt idx="13">
                  <c:v>0.29060000000000002</c:v>
                </c:pt>
                <c:pt idx="14">
                  <c:v>0.2681</c:v>
                </c:pt>
                <c:pt idx="15">
                  <c:v>0.50853300000000001</c:v>
                </c:pt>
                <c:pt idx="16">
                  <c:v>0.50370000000000004</c:v>
                </c:pt>
                <c:pt idx="17">
                  <c:v>0.42306700000000003</c:v>
                </c:pt>
                <c:pt idx="18">
                  <c:v>0.502467</c:v>
                </c:pt>
                <c:pt idx="19">
                  <c:v>0.36696699999999999</c:v>
                </c:pt>
                <c:pt idx="20">
                  <c:v>0.40429999999999999</c:v>
                </c:pt>
                <c:pt idx="21">
                  <c:v>0.45006699999999999</c:v>
                </c:pt>
                <c:pt idx="25">
                  <c:v>1.3965000000000001</c:v>
                </c:pt>
                <c:pt idx="26">
                  <c:v>4.9478999999999997</c:v>
                </c:pt>
                <c:pt idx="27">
                  <c:v>1.37957</c:v>
                </c:pt>
                <c:pt idx="28">
                  <c:v>1.5193300000000001</c:v>
                </c:pt>
                <c:pt idx="29">
                  <c:v>0.92896699999999999</c:v>
                </c:pt>
                <c:pt idx="30">
                  <c:v>7.8499999999999993E-3</c:v>
                </c:pt>
                <c:pt idx="31">
                  <c:v>0.28156700000000001</c:v>
                </c:pt>
                <c:pt idx="32">
                  <c:v>1.1024499999999999</c:v>
                </c:pt>
                <c:pt idx="33">
                  <c:v>0.18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79F0-492B-8922-0FF397DB8A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91170943"/>
        <c:axId val="1591172383"/>
      </c:lineChart>
      <c:catAx>
        <c:axId val="15911709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91172383"/>
        <c:crosses val="autoZero"/>
        <c:auto val="1"/>
        <c:lblAlgn val="ctr"/>
        <c:lblOffset val="100"/>
        <c:noMultiLvlLbl val="0"/>
      </c:catAx>
      <c:valAx>
        <c:axId val="159117238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9117094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TaYSL2-6B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Sheet3!$B$1</c:f>
              <c:strCache>
                <c:ptCount val="1"/>
                <c:pt idx="0">
                  <c:v>C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3!$A$2:$A$5</c:f>
              <c:strCache>
                <c:ptCount val="4"/>
                <c:pt idx="0">
                  <c:v>Cultivars</c:v>
                </c:pt>
                <c:pt idx="1">
                  <c:v>Landraces</c:v>
                </c:pt>
                <c:pt idx="2">
                  <c:v>Spring</c:v>
                </c:pt>
                <c:pt idx="3">
                  <c:v>Winter</c:v>
                </c:pt>
              </c:strCache>
            </c:strRef>
          </c:cat>
          <c:val>
            <c:numRef>
              <c:f>Sheet3!$B$2:$B$5</c:f>
              <c:numCache>
                <c:formatCode>General</c:formatCode>
                <c:ptCount val="4"/>
                <c:pt idx="0">
                  <c:v>630</c:v>
                </c:pt>
                <c:pt idx="1">
                  <c:v>648</c:v>
                </c:pt>
                <c:pt idx="2">
                  <c:v>127</c:v>
                </c:pt>
                <c:pt idx="3">
                  <c:v>10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C3-47E6-BA74-18AA4CC60CBF}"/>
            </c:ext>
          </c:extLst>
        </c:ser>
        <c:ser>
          <c:idx val="1"/>
          <c:order val="1"/>
          <c:tx>
            <c:strRef>
              <c:f>Sheet3!$C$1</c:f>
              <c:strCache>
                <c:ptCount val="1"/>
                <c:pt idx="0">
                  <c:v>T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3!$A$2:$A$5</c:f>
              <c:strCache>
                <c:ptCount val="4"/>
                <c:pt idx="0">
                  <c:v>Cultivars</c:v>
                </c:pt>
                <c:pt idx="1">
                  <c:v>Landraces</c:v>
                </c:pt>
                <c:pt idx="2">
                  <c:v>Spring</c:v>
                </c:pt>
                <c:pt idx="3">
                  <c:v>Winter</c:v>
                </c:pt>
              </c:strCache>
            </c:strRef>
          </c:cat>
          <c:val>
            <c:numRef>
              <c:f>Sheet3!$C$2:$C$5</c:f>
              <c:numCache>
                <c:formatCode>General</c:formatCode>
                <c:ptCount val="4"/>
                <c:pt idx="0">
                  <c:v>64</c:v>
                </c:pt>
                <c:pt idx="1">
                  <c:v>8</c:v>
                </c:pt>
                <c:pt idx="2">
                  <c:v>2</c:v>
                </c:pt>
                <c:pt idx="3">
                  <c:v>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3C3-47E6-BA74-18AA4CC60C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43577167"/>
        <c:axId val="1543582927"/>
      </c:barChart>
      <c:catAx>
        <c:axId val="154357716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43582927"/>
        <c:crosses val="autoZero"/>
        <c:auto val="1"/>
        <c:lblAlgn val="ctr"/>
        <c:lblOffset val="100"/>
        <c:noMultiLvlLbl val="0"/>
      </c:catAx>
      <c:valAx>
        <c:axId val="1543582927"/>
        <c:scaling>
          <c:orientation val="minMax"/>
          <c:min val="0"/>
        </c:scaling>
        <c:delete val="0"/>
        <c:axPos val="b"/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4357716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A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A$2:$A$5</c:f>
              <c:strCache>
                <c:ptCount val="4"/>
                <c:pt idx="0">
                  <c:v>Cultivars</c:v>
                </c:pt>
                <c:pt idx="1">
                  <c:v>Landraces</c:v>
                </c:pt>
                <c:pt idx="2">
                  <c:v>Spring</c:v>
                </c:pt>
                <c:pt idx="3">
                  <c:v>Winter</c:v>
                </c:pt>
              </c:strCache>
            </c:strRef>
          </c:cat>
          <c:val>
            <c:numRef>
              <c:f>Sheet2!$B$2:$B$5</c:f>
              <c:numCache>
                <c:formatCode>General</c:formatCode>
                <c:ptCount val="4"/>
                <c:pt idx="0">
                  <c:v>91</c:v>
                </c:pt>
                <c:pt idx="1">
                  <c:v>62</c:v>
                </c:pt>
                <c:pt idx="2">
                  <c:v>7</c:v>
                </c:pt>
                <c:pt idx="3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6A-40B7-95AD-689176A9A6DD}"/>
            </c:ext>
          </c:extLst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AG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A$2:$A$5</c:f>
              <c:strCache>
                <c:ptCount val="4"/>
                <c:pt idx="0">
                  <c:v>Cultivars</c:v>
                </c:pt>
                <c:pt idx="1">
                  <c:v>Landraces</c:v>
                </c:pt>
                <c:pt idx="2">
                  <c:v>Spring</c:v>
                </c:pt>
                <c:pt idx="3">
                  <c:v>Winter</c:v>
                </c:pt>
              </c:strCache>
            </c:strRef>
          </c:cat>
          <c:val>
            <c:numRef>
              <c:f>Sheet2!$C$2:$C$5</c:f>
              <c:numCache>
                <c:formatCode>General</c:formatCode>
                <c:ptCount val="4"/>
                <c:pt idx="0">
                  <c:v>415</c:v>
                </c:pt>
                <c:pt idx="1">
                  <c:v>552</c:v>
                </c:pt>
                <c:pt idx="2">
                  <c:v>133</c:v>
                </c:pt>
                <c:pt idx="3">
                  <c:v>77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86A-40B7-95AD-689176A9A6DD}"/>
            </c:ext>
          </c:extLst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G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2!$A$2:$A$5</c:f>
              <c:strCache>
                <c:ptCount val="4"/>
                <c:pt idx="0">
                  <c:v>Cultivars</c:v>
                </c:pt>
                <c:pt idx="1">
                  <c:v>Landraces</c:v>
                </c:pt>
                <c:pt idx="2">
                  <c:v>Spring</c:v>
                </c:pt>
                <c:pt idx="3">
                  <c:v>Winter</c:v>
                </c:pt>
              </c:strCache>
            </c:strRef>
          </c:cat>
          <c:val>
            <c:numRef>
              <c:f>Sheet2!$D$2:$D$5</c:f>
              <c:numCache>
                <c:formatCode>General</c:formatCode>
                <c:ptCount val="4"/>
                <c:pt idx="0">
                  <c:v>32</c:v>
                </c:pt>
                <c:pt idx="1">
                  <c:v>13</c:v>
                </c:pt>
                <c:pt idx="2">
                  <c:v>2</c:v>
                </c:pt>
                <c:pt idx="3">
                  <c:v>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86A-40B7-95AD-689176A9A6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91266463"/>
        <c:axId val="1591284703"/>
      </c:barChart>
      <c:catAx>
        <c:axId val="159126646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91284703"/>
        <c:crosses val="autoZero"/>
        <c:auto val="1"/>
        <c:lblAlgn val="ctr"/>
        <c:lblOffset val="100"/>
        <c:noMultiLvlLbl val="0"/>
      </c:catAx>
      <c:valAx>
        <c:axId val="1591284703"/>
        <c:scaling>
          <c:orientation val="minMax"/>
        </c:scaling>
        <c:delete val="0"/>
        <c:axPos val="b"/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9126646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1"/>
          <c:order val="0"/>
          <c:tx>
            <c:strRef>
              <c:f>'D:\Mphil Research\Biofortification\YSL\[embryo data.xlsx]Sheet1'!$C$137</c:f>
              <c:strCache>
                <c:ptCount val="1"/>
                <c:pt idx="0">
                  <c:v>A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D:\Mphil Research\Biofortification\YSL\[embryo data.xlsx]Sheet1'!$D$135:$AK$135</c:f>
              <c:strCache>
                <c:ptCount val="34"/>
                <c:pt idx="0">
                  <c:v>Embryo</c:v>
                </c:pt>
                <c:pt idx="25">
                  <c:v>Endosperm</c:v>
                </c:pt>
              </c:strCache>
            </c:strRef>
          </c:cat>
          <c:val>
            <c:numRef>
              <c:f>'D:\Mphil Research\Biofortification\YSL\[embryo data.xlsx]Sheet1'!$D$137:$AK$137</c:f>
              <c:numCache>
                <c:formatCode>General</c:formatCode>
                <c:ptCount val="34"/>
                <c:pt idx="0">
                  <c:v>0</c:v>
                </c:pt>
                <c:pt idx="1">
                  <c:v>0</c:v>
                </c:pt>
                <c:pt idx="2">
                  <c:v>1.08667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8.6333299999999998E-3</c:v>
                </c:pt>
                <c:pt idx="9">
                  <c:v>1.60667E-2</c:v>
                </c:pt>
                <c:pt idx="10">
                  <c:v>0</c:v>
                </c:pt>
                <c:pt idx="11">
                  <c:v>1.43333E-2</c:v>
                </c:pt>
                <c:pt idx="12">
                  <c:v>0</c:v>
                </c:pt>
                <c:pt idx="13">
                  <c:v>0</c:v>
                </c:pt>
                <c:pt idx="14">
                  <c:v>4.7000000000000002E-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4.7999999999999996E-3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793-4330-B505-E49123B8EB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44886943"/>
        <c:axId val="644885023"/>
      </c:lineChart>
      <c:catAx>
        <c:axId val="6448869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44885023"/>
        <c:crosses val="autoZero"/>
        <c:auto val="1"/>
        <c:lblAlgn val="ctr"/>
        <c:lblOffset val="100"/>
        <c:noMultiLvlLbl val="0"/>
      </c:catAx>
      <c:valAx>
        <c:axId val="64488502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4488694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07D6AE-69EA-4BC8-8048-230CC25238E7}" type="datetimeFigureOut">
              <a:rPr lang="en-US" smtClean="0"/>
              <a:t>5/8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49670F-84F4-4E7F-8709-1C4A496264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4014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649670F-84F4-4E7F-8709-1C4A496264F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28194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649670F-84F4-4E7F-8709-1C4A496264F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477520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649670F-84F4-4E7F-8709-1C4A496264F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1401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5A1F84-33CC-CC91-0DBD-E5392A34B3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5EE996D-C764-9752-F5A0-A20CCC2D29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F2E6D-29E7-524B-A216-7FDC7C30C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654C-39AB-4977-8143-2B9763E9BC6E}" type="datetimeFigureOut">
              <a:rPr lang="en-US" smtClean="0"/>
              <a:t>5/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6D0228-6637-3412-0E5E-664F62B2D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4455E1-48D1-59CF-8B49-94A5B0E91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633B1-1A38-4B83-84EA-D12F062C2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328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B28259-59F7-CD83-2172-EEB53B624D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8EFDC9-6B33-BDB7-F3EC-3F7FD52252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BB08F1-B67C-C6EB-ED9F-40738E8301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654C-39AB-4977-8143-2B9763E9BC6E}" type="datetimeFigureOut">
              <a:rPr lang="en-US" smtClean="0"/>
              <a:t>5/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FF6DA9-E0CF-7826-8446-DB5B60F80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330BA2-DE04-1CDB-0B9E-320501890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633B1-1A38-4B83-84EA-D12F062C2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762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03DD7B-C891-BF55-C189-4E198645064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550181-4DDF-D61D-C542-C185ABE510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28D16D-A5C8-6411-73F4-B234A39E9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654C-39AB-4977-8143-2B9763E9BC6E}" type="datetimeFigureOut">
              <a:rPr lang="en-US" smtClean="0"/>
              <a:t>5/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3AE3B6-ECEF-D255-D900-1DFABC8645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A02870-FCEC-45AB-2FF9-74D3D3257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633B1-1A38-4B83-84EA-D12F062C2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0887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1685A6-BD38-BB6B-E8E6-DDCC1FF9F4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24C600-F609-9561-2EB4-6FCFE2BB71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73FD26-A134-B9DC-F1E8-64A2D7114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654C-39AB-4977-8143-2B9763E9BC6E}" type="datetimeFigureOut">
              <a:rPr lang="en-US" smtClean="0"/>
              <a:t>5/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842966-8B38-6374-FCA4-36212C8F17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8E03F1-9D4E-B3ED-205A-7673DE3E6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633B1-1A38-4B83-84EA-D12F062C2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311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2BA074-C375-2ED3-3F7B-6088D821A8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2E2217-3659-4D01-526A-CB52BDD0A1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F2DCC3-0358-B952-903E-D763CD64E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654C-39AB-4977-8143-2B9763E9BC6E}" type="datetimeFigureOut">
              <a:rPr lang="en-US" smtClean="0"/>
              <a:t>5/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402251-F412-B1FA-AF6E-61E016E93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01F60E-07CB-7318-630F-B1E1C78289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633B1-1A38-4B83-84EA-D12F062C2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750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0B86E9-E879-C123-426A-4BB3FEB738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CCE433-5D87-0D5D-2FCD-F6D35362C8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50DCB4-0865-B40F-32B3-3C5242042D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8E9F11-0796-BFE4-E9BB-27C43E7119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654C-39AB-4977-8143-2B9763E9BC6E}" type="datetimeFigureOut">
              <a:rPr lang="en-US" smtClean="0"/>
              <a:t>5/8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D99653-783D-7C56-89E2-E1FD28C7E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D04416-E899-98EF-95AD-895848F9B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633B1-1A38-4B83-84EA-D12F062C2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196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F4CCCB-6E7D-F3D4-3DF8-5A7DCD99C2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049E11-E7D3-8440-7462-9D3AC50102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6D5B30-425E-D623-3D6D-F0F6055506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DAB572B-7037-39FE-7C1A-7E1C4D2FE3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0FD6F38-65ED-107E-4DAF-94D7D00B25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AB5C6F-04D6-6EC5-812C-8A59571F5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654C-39AB-4977-8143-2B9763E9BC6E}" type="datetimeFigureOut">
              <a:rPr lang="en-US" smtClean="0"/>
              <a:t>5/8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5968A37-29B5-8F48-FE0E-25BCF96782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1661CC5-9054-70F2-5671-75B4B2166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633B1-1A38-4B83-84EA-D12F062C2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409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7D111B-7ADC-E0C0-FBC4-F51DA124F1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E403B5A-090A-CEF2-0A4B-AC81E250C6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654C-39AB-4977-8143-2B9763E9BC6E}" type="datetimeFigureOut">
              <a:rPr lang="en-US" smtClean="0"/>
              <a:t>5/8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622C8E1-7C39-2708-629E-24D17FBF9D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FF9BE4-09DA-9D4E-B006-712D4B099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633B1-1A38-4B83-84EA-D12F062C2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370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E8DDDA-1D3A-3149-C6DB-B00D590F7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654C-39AB-4977-8143-2B9763E9BC6E}" type="datetimeFigureOut">
              <a:rPr lang="en-US" smtClean="0"/>
              <a:t>5/8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2A53E1B-E4B9-E2EE-B8B6-3AAC942887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9A5A40B-0D3B-8F59-E21E-97FD06156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633B1-1A38-4B83-84EA-D12F062C2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718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1EAB9C-554C-DDE1-83B6-0EE039B5AC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3A09C7-7793-BAA9-7787-6AD49CB595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7A124C-46AF-10A4-E440-D6E1B1AA8D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EFE806-F76F-F2A4-86B9-5D4C5208C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654C-39AB-4977-8143-2B9763E9BC6E}" type="datetimeFigureOut">
              <a:rPr lang="en-US" smtClean="0"/>
              <a:t>5/8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CB338D-84F0-0644-F180-5BE2DFC3B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6283F3-93CB-5FD0-11ED-041AE572B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633B1-1A38-4B83-84EA-D12F062C2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384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0237E1-C404-34A8-A71B-E98C172474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EEC9D64-AA20-6358-D29C-240243528C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AFC813-3A30-D770-BFF2-DE45F0C9A9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37DFA0-DD51-13E5-DA46-420D88AE8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654C-39AB-4977-8143-2B9763E9BC6E}" type="datetimeFigureOut">
              <a:rPr lang="en-US" smtClean="0"/>
              <a:t>5/8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F8D54E-7186-5A18-96DF-77D8E98B32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956B00-EA02-73EF-BF6D-FF94C5D6E1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633B1-1A38-4B83-84EA-D12F062C2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788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786E8CF-77B1-A811-141F-0CB17449FF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61A368-F87C-8A01-0344-A51A0157DB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EE06B0-6AAC-1B1B-B544-390DBB7500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350654C-39AB-4977-8143-2B9763E9BC6E}" type="datetimeFigureOut">
              <a:rPr lang="en-US" smtClean="0"/>
              <a:t>5/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19C037-95D7-3783-69B6-E0A046D10D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7E5986-EAD2-B92C-85DA-4A97CD6B17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CA633B1-1A38-4B83-84EA-D12F062C2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85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sv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6.png"/><Relationship Id="rId4" Type="http://schemas.openxmlformats.org/officeDocument/2006/relationships/chart" Target="../charts/char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7.png"/><Relationship Id="rId4" Type="http://schemas.openxmlformats.org/officeDocument/2006/relationships/chart" Target="../charts/chart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6FC1516-BF3D-4235-3F84-1FDE51BEF93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063A068-3D8B-30F8-CE7D-1E161FA63E39}"/>
              </a:ext>
            </a:extLst>
          </p:cNvPr>
          <p:cNvSpPr txBox="1"/>
          <p:nvPr/>
        </p:nvSpPr>
        <p:spPr>
          <a:xfrm>
            <a:off x="413657" y="5606143"/>
            <a:ext cx="1114697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Overview of conserved sequence motifs, domain and gene structures of the TaYSLs. (A) Phylogenetic tree based on full-length amino acid sequences of TaYSL proteins. (B) Distribution of conserved motifs of TaYSL proteins (C) Predicted functional domain of TaYSL proteins (D) Exon-intron structures of 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YS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genes.  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984B291A-006B-A3D9-E973-57608261EA38}"/>
              </a:ext>
            </a:extLst>
          </p:cNvPr>
          <p:cNvGrpSpPr/>
          <p:nvPr/>
        </p:nvGrpSpPr>
        <p:grpSpPr>
          <a:xfrm>
            <a:off x="1879056" y="641124"/>
            <a:ext cx="7885430" cy="4965019"/>
            <a:chOff x="0" y="0"/>
            <a:chExt cx="12128396" cy="6684883"/>
          </a:xfrm>
        </p:grpSpPr>
        <p:pic>
          <p:nvPicPr>
            <p:cNvPr id="7" name="Graphic 4">
              <a:extLst>
                <a:ext uri="{FF2B5EF4-FFF2-40B4-BE49-F238E27FC236}">
                  <a16:creationId xmlns:a16="http://schemas.microsoft.com/office/drawing/2014/main" id="{BE3E982C-0A17-E2FB-CFF4-97653CCCC937}"/>
                </a:ext>
              </a:extLst>
            </p:cNvPr>
            <p:cNvPicPr>
              <a:picLocks noChangeAspect="1"/>
            </p:cNvPicPr>
            <p:nvPr/>
          </p:nvPicPr>
          <p:blipFill>
            <a:blip>
              <a:extLst>
                <a:ext uri="{96DAC541-7B7A-43D3-8B79-37D633B846F1}">
                  <asvg:svgBlip xmlns:asvg="http://schemas.microsoft.com/office/drawing/2016/SVG/main" r:embed="rId2"/>
                </a:ext>
              </a:extLst>
            </a:blip>
            <a:srcRect l="16875" t="5564" r="56875" b="3717"/>
            <a:stretch/>
          </p:blipFill>
          <p:spPr>
            <a:xfrm>
              <a:off x="0" y="0"/>
              <a:ext cx="4122718" cy="6511763"/>
            </a:xfrm>
            <a:prstGeom prst="rect">
              <a:avLst/>
            </a:prstGeom>
          </p:spPr>
        </p:pic>
        <p:pic>
          <p:nvPicPr>
            <p:cNvPr id="8" name="Picture 7" descr="A group of colorful lines&#10;&#10;AI-generated content may be incorrect.">
              <a:extLst>
                <a:ext uri="{FF2B5EF4-FFF2-40B4-BE49-F238E27FC236}">
                  <a16:creationId xmlns:a16="http://schemas.microsoft.com/office/drawing/2014/main" id="{0EE68CF7-7A56-0F58-04A1-D2E1D36AA57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52" t="2038"/>
            <a:stretch/>
          </p:blipFill>
          <p:spPr>
            <a:xfrm>
              <a:off x="3742538" y="0"/>
              <a:ext cx="8385858" cy="668488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4978114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D14B73A-9A21-6792-4899-890E63039F5A}"/>
              </a:ext>
            </a:extLst>
          </p:cNvPr>
          <p:cNvGrpSpPr/>
          <p:nvPr/>
        </p:nvGrpSpPr>
        <p:grpSpPr>
          <a:xfrm>
            <a:off x="1335336" y="147863"/>
            <a:ext cx="9212921" cy="5501823"/>
            <a:chOff x="0" y="0"/>
            <a:chExt cx="11114620" cy="6585857"/>
          </a:xfrm>
        </p:grpSpPr>
        <p:pic>
          <p:nvPicPr>
            <p:cNvPr id="3" name="Picture 2" descr="A grid of lines with different colored dots&#10;&#10;AI-generated content may be incorrect.">
              <a:extLst>
                <a:ext uri="{FF2B5EF4-FFF2-40B4-BE49-F238E27FC236}">
                  <a16:creationId xmlns:a16="http://schemas.microsoft.com/office/drawing/2014/main" id="{629A163B-2989-E049-8509-18FC28E961D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587" r="8393" b="10952"/>
            <a:stretch/>
          </p:blipFill>
          <p:spPr>
            <a:xfrm>
              <a:off x="0" y="0"/>
              <a:ext cx="6923245" cy="6585857"/>
            </a:xfrm>
            <a:prstGeom prst="rect">
              <a:avLst/>
            </a:prstGeom>
          </p:spPr>
        </p:pic>
        <p:pic>
          <p:nvPicPr>
            <p:cNvPr id="4" name="Picture 3" descr="A chart of data&#10;&#10;AI-generated content may be incorrect.">
              <a:extLst>
                <a:ext uri="{FF2B5EF4-FFF2-40B4-BE49-F238E27FC236}">
                  <a16:creationId xmlns:a16="http://schemas.microsoft.com/office/drawing/2014/main" id="{2C8A8544-6740-275B-DA04-5ED24A58BED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83" t="1984"/>
            <a:stretch/>
          </p:blipFill>
          <p:spPr>
            <a:xfrm>
              <a:off x="6760333" y="0"/>
              <a:ext cx="4354287" cy="6252956"/>
            </a:xfrm>
            <a:prstGeom prst="rect">
              <a:avLst/>
            </a:prstGeom>
          </p:spPr>
        </p:pic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EED83D9B-4471-8688-70ED-95AD69E7D1EA}"/>
              </a:ext>
            </a:extLst>
          </p:cNvPr>
          <p:cNvSpPr txBox="1"/>
          <p:nvPr/>
        </p:nvSpPr>
        <p:spPr>
          <a:xfrm>
            <a:off x="696685" y="5780314"/>
            <a:ext cx="1030877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The cis-regulatory elements in the promoter region of 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YSL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. Color intensity and value indicate the count of each cis element in the promoter while bar on the right shows category-wise distribution of cis elements in each gene.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12772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DAE4E0A-039C-F4D8-229A-C5276E643A0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395E882-1C8C-41AD-93BB-95F4610D60AD}"/>
              </a:ext>
            </a:extLst>
          </p:cNvPr>
          <p:cNvSpPr txBox="1"/>
          <p:nvPr/>
        </p:nvSpPr>
        <p:spPr>
          <a:xfrm>
            <a:off x="751113" y="5595257"/>
            <a:ext cx="103087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Pie chart showing proportion of SNPs in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YS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by type and genomic region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467D339-4DB7-C844-A1F4-993B3A9488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1465" y="718139"/>
            <a:ext cx="6529070" cy="4115435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</p:spTree>
    <p:extLst>
      <p:ext uri="{BB962C8B-B14F-4D97-AF65-F5344CB8AC3E}">
        <p14:creationId xmlns:p14="http://schemas.microsoft.com/office/powerpoint/2010/main" val="36811741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FA2BF6BE-FF50-2363-3039-837B2B7DDD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551662"/>
              </p:ext>
            </p:extLst>
          </p:nvPr>
        </p:nvGraphicFramePr>
        <p:xfrm>
          <a:off x="7322748" y="811113"/>
          <a:ext cx="4956338" cy="27913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90E90A11-4D44-B3D3-F9EB-4664DE203A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4639547"/>
              </p:ext>
            </p:extLst>
          </p:nvPr>
        </p:nvGraphicFramePr>
        <p:xfrm>
          <a:off x="7444007" y="3537574"/>
          <a:ext cx="4835079" cy="24937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24E5B27C-8B3E-4501-9A68-08818CE987ED}"/>
              </a:ext>
            </a:extLst>
          </p:cNvPr>
          <p:cNvSpPr txBox="1"/>
          <p:nvPr/>
        </p:nvSpPr>
        <p:spPr>
          <a:xfrm>
            <a:off x="4480396" y="86288"/>
            <a:ext cx="2842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YSL1B-1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3100104-08CC-4BF4-CE5B-D9106CED7F84}"/>
              </a:ext>
            </a:extLst>
          </p:cNvPr>
          <p:cNvSpPr txBox="1"/>
          <p:nvPr/>
        </p:nvSpPr>
        <p:spPr>
          <a:xfrm>
            <a:off x="184370" y="836007"/>
            <a:ext cx="694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56EF186-7503-C830-8D35-1EC124DADF3D}"/>
              </a:ext>
            </a:extLst>
          </p:cNvPr>
          <p:cNvSpPr txBox="1"/>
          <p:nvPr/>
        </p:nvSpPr>
        <p:spPr>
          <a:xfrm>
            <a:off x="7160976" y="3233118"/>
            <a:ext cx="694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398CE22-03FF-0980-6420-DE48310B3C9A}"/>
              </a:ext>
            </a:extLst>
          </p:cNvPr>
          <p:cNvSpPr txBox="1"/>
          <p:nvPr/>
        </p:nvSpPr>
        <p:spPr>
          <a:xfrm>
            <a:off x="7096874" y="875768"/>
            <a:ext cx="694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D0C9C84B-3D03-A4A8-54C8-8BBB7014BD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2858" y="1652720"/>
            <a:ext cx="6876859" cy="349215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B4B764C-0D18-4ADD-713D-6B8A43E841F9}"/>
              </a:ext>
            </a:extLst>
          </p:cNvPr>
          <p:cNvSpPr txBox="1"/>
          <p:nvPr/>
        </p:nvSpPr>
        <p:spPr>
          <a:xfrm>
            <a:off x="162858" y="5990111"/>
            <a:ext cx="114630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Boxplot show significant associations between GFeC and TaYSL1B-1A across five environments and their mean, alongside frequencies of favorable alleles in global wheat collections and across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bryo and endosperm tissue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3318053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283B05A-AC76-1ABB-7EA3-8894AC7E9CE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AutoShape 2">
            <a:extLst>
              <a:ext uri="{FF2B5EF4-FFF2-40B4-BE49-F238E27FC236}">
                <a16:creationId xmlns:a16="http://schemas.microsoft.com/office/drawing/2014/main" id="{591C172C-F817-35FB-4DFC-0EDDA52D69BE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b="1"/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82093DFC-C06A-B892-7A19-0DDDB7855C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8417372"/>
              </p:ext>
            </p:extLst>
          </p:nvPr>
        </p:nvGraphicFramePr>
        <p:xfrm>
          <a:off x="7729574" y="3771822"/>
          <a:ext cx="4784615" cy="220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98C32CA-F010-708B-9A8A-21E0D91BDF3F}"/>
              </a:ext>
            </a:extLst>
          </p:cNvPr>
          <p:cNvSpPr txBox="1"/>
          <p:nvPr/>
        </p:nvSpPr>
        <p:spPr>
          <a:xfrm>
            <a:off x="4407013" y="229199"/>
            <a:ext cx="2842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YSL2-6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7595F6A-9F58-469C-083A-04CD3DBD956C}"/>
              </a:ext>
            </a:extLst>
          </p:cNvPr>
          <p:cNvSpPr txBox="1"/>
          <p:nvPr/>
        </p:nvSpPr>
        <p:spPr>
          <a:xfrm>
            <a:off x="166025" y="1140865"/>
            <a:ext cx="694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CEBFF0-BED1-CD78-C50A-A575FA4085F9}"/>
              </a:ext>
            </a:extLst>
          </p:cNvPr>
          <p:cNvSpPr txBox="1"/>
          <p:nvPr/>
        </p:nvSpPr>
        <p:spPr>
          <a:xfrm>
            <a:off x="7389846" y="3616750"/>
            <a:ext cx="694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AFC1986-544E-9DB4-13CC-B55684F56AF7}"/>
              </a:ext>
            </a:extLst>
          </p:cNvPr>
          <p:cNvSpPr txBox="1"/>
          <p:nvPr/>
        </p:nvSpPr>
        <p:spPr>
          <a:xfrm>
            <a:off x="7382441" y="1140865"/>
            <a:ext cx="694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90EF301C-7389-8985-8F41-5FF7B65F9F7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5677086"/>
              </p:ext>
            </p:extLst>
          </p:nvPr>
        </p:nvGraphicFramePr>
        <p:xfrm>
          <a:off x="7382441" y="920819"/>
          <a:ext cx="494511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7" name="Picture 6">
            <a:extLst>
              <a:ext uri="{FF2B5EF4-FFF2-40B4-BE49-F238E27FC236}">
                <a16:creationId xmlns:a16="http://schemas.microsoft.com/office/drawing/2014/main" id="{ACBEA71B-18D6-3B16-8640-468AA6E18B5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1604036"/>
            <a:ext cx="6894449" cy="350108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E4D621D-E3C4-43CD-4F14-59DD16870D6D}"/>
              </a:ext>
            </a:extLst>
          </p:cNvPr>
          <p:cNvSpPr txBox="1"/>
          <p:nvPr/>
        </p:nvSpPr>
        <p:spPr>
          <a:xfrm>
            <a:off x="326571" y="5898285"/>
            <a:ext cx="115388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Boxplot show significant associations between GFeC and TaYSL2-6B across five environments and their mean, alongside frequencies of favorable alleles in global wheat collections and across embryo and endosperm tissues.</a:t>
            </a:r>
          </a:p>
        </p:txBody>
      </p:sp>
    </p:spTree>
    <p:extLst>
      <p:ext uri="{BB962C8B-B14F-4D97-AF65-F5344CB8AC3E}">
        <p14:creationId xmlns:p14="http://schemas.microsoft.com/office/powerpoint/2010/main" val="35502485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AED03E67-8748-4D83-6BB2-9881F4C76D9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8361694"/>
              </p:ext>
            </p:extLst>
          </p:nvPr>
        </p:nvGraphicFramePr>
        <p:xfrm>
          <a:off x="82193" y="3665368"/>
          <a:ext cx="4349259" cy="23719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148ACE4C-BBAF-4A9D-8D3A-BAB250AE9A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46469477"/>
              </p:ext>
            </p:extLst>
          </p:nvPr>
        </p:nvGraphicFramePr>
        <p:xfrm>
          <a:off x="4579794" y="3755859"/>
          <a:ext cx="4507488" cy="23269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0B3B118D-11AF-150A-C451-C8A267FBE3D1}"/>
              </a:ext>
            </a:extLst>
          </p:cNvPr>
          <p:cNvSpPr txBox="1"/>
          <p:nvPr/>
        </p:nvSpPr>
        <p:spPr>
          <a:xfrm>
            <a:off x="4847736" y="39697"/>
            <a:ext cx="2842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YSL7-7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16F92D4-94CE-F241-8145-948E938E318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2775" y="1088245"/>
            <a:ext cx="3937032" cy="448215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D286A96-06DE-60A3-0DA0-21A4904B0E68}"/>
              </a:ext>
            </a:extLst>
          </p:cNvPr>
          <p:cNvSpPr txBox="1"/>
          <p:nvPr/>
        </p:nvSpPr>
        <p:spPr>
          <a:xfrm>
            <a:off x="0" y="718913"/>
            <a:ext cx="1129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2CE7368-158C-EB6A-718E-B3B7D6742F80}"/>
              </a:ext>
            </a:extLst>
          </p:cNvPr>
          <p:cNvSpPr txBox="1"/>
          <p:nvPr/>
        </p:nvSpPr>
        <p:spPr>
          <a:xfrm>
            <a:off x="4283110" y="3512066"/>
            <a:ext cx="1129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042B4DD-E746-2330-C859-130C1A9A1B75}"/>
              </a:ext>
            </a:extLst>
          </p:cNvPr>
          <p:cNvSpPr txBox="1"/>
          <p:nvPr/>
        </p:nvSpPr>
        <p:spPr>
          <a:xfrm>
            <a:off x="82193" y="3530906"/>
            <a:ext cx="1129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16BC68-9E29-78A3-870E-ABDF49F43163}"/>
              </a:ext>
            </a:extLst>
          </p:cNvPr>
          <p:cNvSpPr txBox="1"/>
          <p:nvPr/>
        </p:nvSpPr>
        <p:spPr>
          <a:xfrm>
            <a:off x="7690088" y="1088245"/>
            <a:ext cx="1129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D33B0DEE-69F0-5174-FD91-3E3B17E2D3C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8351" y="462675"/>
            <a:ext cx="5660563" cy="287450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F2F33BF-9CD5-75F9-BA23-4DDA25637DB1}"/>
              </a:ext>
            </a:extLst>
          </p:cNvPr>
          <p:cNvSpPr txBox="1"/>
          <p:nvPr/>
        </p:nvSpPr>
        <p:spPr>
          <a:xfrm>
            <a:off x="250371" y="6037360"/>
            <a:ext cx="11859436" cy="657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Boxplot show significant associations between GFeC and TaYSL7-7A across five environments and their mean, alongside frequencies of favorable alleles in global wheat collections and across embryo and endosperm tissues.</a:t>
            </a:r>
          </a:p>
        </p:txBody>
      </p:sp>
    </p:spTree>
    <p:extLst>
      <p:ext uri="{BB962C8B-B14F-4D97-AF65-F5344CB8AC3E}">
        <p14:creationId xmlns:p14="http://schemas.microsoft.com/office/powerpoint/2010/main" val="40734376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3</TotalTime>
  <Words>239</Words>
  <Application>Microsoft Office PowerPoint</Application>
  <PresentationFormat>Widescreen</PresentationFormat>
  <Paragraphs>23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inat Abbasi</dc:creator>
  <cp:lastModifiedBy>Kainat Abbasi</cp:lastModifiedBy>
  <cp:revision>37</cp:revision>
  <dcterms:created xsi:type="dcterms:W3CDTF">2025-12-16T07:53:55Z</dcterms:created>
  <dcterms:modified xsi:type="dcterms:W3CDTF">2026-05-08T10:20:19Z</dcterms:modified>
</cp:coreProperties>
</file>